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F634C-883D-4F5C-880E-49ED909062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110FEE-8755-4C2F-B722-C32BB43097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A4227-2BDE-4ED1-91F4-61D9817CF1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DD8AD-703E-4341-B229-45CA018931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EB07F-70AB-4B79-B003-D214BDC3BF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8F5338-F1CE-4BE4-A4DD-9D61607787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CFB4BB-B6A8-4C9C-9B18-4C015594FA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AE3CE-016F-4201-BEFC-9BF6CAC2DD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C527E-53D5-45B5-BFE6-1A4926C47F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50594-4AD9-481D-A6DE-1D8BE43583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25575-9590-4FE9-99CA-F33E96CAE1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2EB8BF-8435-499E-AA27-F01E3B62DD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BC0D21-3AA8-4DA3-A2D3-723C93823FE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78080" y="1374840"/>
            <a:ext cx="2592360" cy="1109520"/>
          </a:xfrm>
          <a:prstGeom prst="diamond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278080" y="3929040"/>
            <a:ext cx="2592360" cy="1109520"/>
          </a:xfrm>
          <a:prstGeom prst="diamond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278080" y="5292720"/>
            <a:ext cx="2592360" cy="1109520"/>
          </a:xfrm>
          <a:prstGeom prst="diamond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278080" y="6664320"/>
            <a:ext cx="2592360" cy="1109520"/>
          </a:xfrm>
          <a:prstGeom prst="diamond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60280" y="2844720"/>
            <a:ext cx="1927440" cy="525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&amp; expression dat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IBC &amp; nIB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6" name=""/>
          <p:cNvCxnSpPr>
            <a:stCxn id="47" idx="2"/>
            <a:endCxn id="41" idx="0"/>
          </p:cNvCxnSpPr>
          <p:nvPr/>
        </p:nvCxnSpPr>
        <p:spPr>
          <a:xfrm rot="5400000">
            <a:off x="3301920" y="1100520"/>
            <a:ext cx="546480" cy="2880"/>
          </a:xfrm>
          <a:prstGeom prst="bentConnector3">
            <a:avLst>
              <a:gd name="adj1" fmla="val 49901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8" name=""/>
          <p:cNvCxnSpPr>
            <a:stCxn id="42" idx="2"/>
            <a:endCxn id="43" idx="0"/>
          </p:cNvCxnSpPr>
          <p:nvPr/>
        </p:nvCxnSpPr>
        <p:spPr>
          <a:xfrm rot="16200000">
            <a:off x="3447000" y="5165640"/>
            <a:ext cx="254520" cy="3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9" name=""/>
          <p:cNvCxnSpPr>
            <a:stCxn id="43" idx="2"/>
            <a:endCxn id="44" idx="0"/>
          </p:cNvCxnSpPr>
          <p:nvPr/>
        </p:nvCxnSpPr>
        <p:spPr>
          <a:xfrm rot="16200000">
            <a:off x="3443040" y="6533280"/>
            <a:ext cx="262440" cy="3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"/>
          <p:cNvCxnSpPr>
            <a:stCxn id="44" idx="2"/>
            <a:endCxn id="51" idx="0"/>
          </p:cNvCxnSpPr>
          <p:nvPr/>
        </p:nvCxnSpPr>
        <p:spPr>
          <a:xfrm flipH="1" rot="16200000">
            <a:off x="3451320" y="7896240"/>
            <a:ext cx="246600" cy="1440"/>
          </a:xfrm>
          <a:prstGeom prst="bentConnector3">
            <a:avLst>
              <a:gd name="adj1" fmla="val 50292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2" name=""/>
          <p:cNvCxnSpPr>
            <a:stCxn id="41" idx="3"/>
            <a:endCxn id="53" idx="2"/>
          </p:cNvCxnSpPr>
          <p:nvPr/>
        </p:nvCxnSpPr>
        <p:spPr>
          <a:xfrm>
            <a:off x="4870440" y="1929600"/>
            <a:ext cx="1079640" cy="2138760"/>
          </a:xfrm>
          <a:prstGeom prst="bentConnector3">
            <a:avLst>
              <a:gd name="adj1" fmla="val 50333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54" name=""/>
          <p:cNvCxnSpPr>
            <a:stCxn id="42" idx="3"/>
            <a:endCxn id="53" idx="2"/>
          </p:cNvCxnSpPr>
          <p:nvPr/>
        </p:nvCxnSpPr>
        <p:spPr>
          <a:xfrm flipV="1">
            <a:off x="4870440" y="4068000"/>
            <a:ext cx="1079640" cy="416160"/>
          </a:xfrm>
          <a:prstGeom prst="bentConnector3">
            <a:avLst>
              <a:gd name="adj1" fmla="val 50333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55" name=""/>
          <p:cNvCxnSpPr>
            <a:stCxn id="43" idx="3"/>
            <a:endCxn id="53" idx="2"/>
          </p:cNvCxnSpPr>
          <p:nvPr/>
        </p:nvCxnSpPr>
        <p:spPr>
          <a:xfrm flipV="1">
            <a:off x="4870440" y="4068000"/>
            <a:ext cx="1079640" cy="1779840"/>
          </a:xfrm>
          <a:prstGeom prst="bentConnector3">
            <a:avLst>
              <a:gd name="adj1" fmla="val 50333"/>
            </a:avLst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56" name=""/>
          <p:cNvCxnSpPr>
            <a:stCxn id="44" idx="3"/>
            <a:endCxn id="53" idx="2"/>
          </p:cNvCxnSpPr>
          <p:nvPr/>
        </p:nvCxnSpPr>
        <p:spPr>
          <a:xfrm flipV="1">
            <a:off x="4870440" y="4068000"/>
            <a:ext cx="1079640" cy="3151440"/>
          </a:xfrm>
          <a:prstGeom prst="bentConnector3">
            <a:avLst>
              <a:gd name="adj1" fmla="val 50333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7" name=""/>
          <p:cNvCxnSpPr>
            <a:stCxn id="41" idx="2"/>
            <a:endCxn id="58" idx="0"/>
          </p:cNvCxnSpPr>
          <p:nvPr/>
        </p:nvCxnSpPr>
        <p:spPr>
          <a:xfrm rot="5400000">
            <a:off x="3393360" y="2664000"/>
            <a:ext cx="360720" cy="1080"/>
          </a:xfrm>
          <a:prstGeom prst="bentConnector3">
            <a:avLst>
              <a:gd name="adj1" fmla="val 50149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3" name=""/>
          <p:cNvSpPr/>
          <p:nvPr/>
        </p:nvSpPr>
        <p:spPr>
          <a:xfrm rot="5400000">
            <a:off x="4545360" y="3744000"/>
            <a:ext cx="3456000" cy="647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566520" y="24843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≤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566520" y="49910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≤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566520" y="63532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≤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566520" y="7704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≤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114960" y="2809800"/>
            <a:ext cx="317520" cy="25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REJECTE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676600" y="181080"/>
            <a:ext cx="1800000" cy="64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701800" y="179280"/>
            <a:ext cx="1774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Genomic da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IBC &amp; nIB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506680" y="1608120"/>
            <a:ext cx="215892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mparis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of CNA frequenci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849920" y="1725480"/>
            <a:ext cx="57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g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841480" y="2085840"/>
            <a:ext cx="1440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Fisher exact tes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849920" y="4268880"/>
            <a:ext cx="57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g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849920" y="5635800"/>
            <a:ext cx="57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g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849920" y="6997680"/>
            <a:ext cx="57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g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682720" y="4075200"/>
            <a:ext cx="1787760" cy="73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1. Comparis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of combined alterations frequenci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638440" y="5440320"/>
            <a:ext cx="187956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2. Comparis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of expression levels according to C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638440" y="8020080"/>
            <a:ext cx="1873080" cy="720720"/>
          </a:xfrm>
          <a:prstGeom prst="ellipse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andidate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04640" y="2755800"/>
            <a:ext cx="532800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871720" y="4678200"/>
            <a:ext cx="1440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Fisher exact tes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871720" y="6064200"/>
            <a:ext cx="1440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(Student t-tes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-421920" y="863280"/>
            <a:ext cx="2016360" cy="647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aCG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analys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16200000">
            <a:off x="-1214280" y="5402160"/>
            <a:ext cx="3672000" cy="718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Integrated analys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- aCGH &amp; mRNA expression 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494080" y="2844720"/>
            <a:ext cx="2158920" cy="5270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693880" y="2879640"/>
            <a:ext cx="175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500 genes common to both platform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9" name=""/>
          <p:cNvCxnSpPr>
            <a:stCxn id="58" idx="2"/>
            <a:endCxn id="42" idx="0"/>
          </p:cNvCxnSpPr>
          <p:nvPr/>
        </p:nvCxnSpPr>
        <p:spPr>
          <a:xfrm flipH="1" rot="16200000">
            <a:off x="3295080" y="3650040"/>
            <a:ext cx="557640" cy="10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0" name=""/>
          <p:cNvSpPr/>
          <p:nvPr/>
        </p:nvSpPr>
        <p:spPr>
          <a:xfrm>
            <a:off x="2816280" y="874800"/>
            <a:ext cx="75816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C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thresho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1" lang="fr-FR" sz="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566520" y="97164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|0.5| &amp; |1|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730600" y="3395520"/>
            <a:ext cx="86184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thresho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1" lang="fr-FR" sz="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566880" y="34923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|1|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630520" y="6815160"/>
            <a:ext cx="187956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3. Comparis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of expression levels according to IBC/nIB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863800" y="7435800"/>
            <a:ext cx="1440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(Student t-tes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6" name=""/>
          <p:cNvCxnSpPr>
            <a:stCxn id="45" idx="3"/>
            <a:endCxn id="58" idx="1"/>
          </p:cNvCxnSpPr>
          <p:nvPr/>
        </p:nvCxnSpPr>
        <p:spPr>
          <a:xfrm>
            <a:off x="2187720" y="3107520"/>
            <a:ext cx="306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7" name=""/>
          <p:cNvSpPr/>
          <p:nvPr/>
        </p:nvSpPr>
        <p:spPr>
          <a:xfrm>
            <a:off x="5444640" y="877716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5T13:24:20Z</dcterms:created>
  <dc:creator>finettip</dc:creator>
  <dc:description/>
  <dc:language>en-US</dc:language>
  <cp:lastModifiedBy>Bertucci</cp:lastModifiedBy>
  <dcterms:modified xsi:type="dcterms:W3CDTF">2010-08-07T14:18:51Z</dcterms:modified>
  <cp:revision>23</cp:revision>
  <dc:subject/>
  <dc:title>Diapositive 1</dc:title>
</cp:coreProperties>
</file>